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80E9D70-2F12-4EBE-AB20-006F725B12F5}" v="1" dt="2025-10-30T16:18:11.35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6" autoAdjust="0"/>
    <p:restoredTop sz="94660"/>
  </p:normalViewPr>
  <p:slideViewPr>
    <p:cSldViewPr snapToGrid="0">
      <p:cViewPr varScale="1">
        <p:scale>
          <a:sx n="66" d="100"/>
          <a:sy n="66" d="100"/>
        </p:scale>
        <p:origin x="62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emertzidou, Anysia" userId="a7f71f62-1794-4728-88f7-f0b545a7c8aa" providerId="ADAL" clId="{D80E9D70-2F12-4EBE-AB20-006F725B12F5}"/>
    <pc:docChg chg="modSld">
      <pc:chgData name="Semertzidou, Anysia" userId="a7f71f62-1794-4728-88f7-f0b545a7c8aa" providerId="ADAL" clId="{D80E9D70-2F12-4EBE-AB20-006F725B12F5}" dt="2025-10-30T16:19:01.991" v="63" actId="255"/>
      <pc:docMkLst>
        <pc:docMk/>
      </pc:docMkLst>
      <pc:sldChg chg="addSp modSp mod">
        <pc:chgData name="Semertzidou, Anysia" userId="a7f71f62-1794-4728-88f7-f0b545a7c8aa" providerId="ADAL" clId="{D80E9D70-2F12-4EBE-AB20-006F725B12F5}" dt="2025-10-30T16:19:01.991" v="63" actId="255"/>
        <pc:sldMkLst>
          <pc:docMk/>
          <pc:sldMk cId="245903416" sldId="256"/>
        </pc:sldMkLst>
        <pc:spChg chg="add mod">
          <ac:chgData name="Semertzidou, Anysia" userId="a7f71f62-1794-4728-88f7-f0b545a7c8aa" providerId="ADAL" clId="{D80E9D70-2F12-4EBE-AB20-006F725B12F5}" dt="2025-10-30T16:19:01.991" v="63" actId="255"/>
          <ac:spMkLst>
            <pc:docMk/>
            <pc:sldMk cId="245903416" sldId="256"/>
            <ac:spMk id="2" creationId="{D8CA715A-0257-0C63-F595-E2BC85DAAD2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CB4FDD-0DA7-D5E2-2E85-14D27E600FE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947A2A7-7873-A232-91DF-6C0874456E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C18568-A9B9-C810-3C2F-6E27F2A3D9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A2791-E7C5-42F3-8DD7-00C8BD603F9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FFDCE6-4030-2F20-56CA-8B244E5AC8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C58691-6917-010D-5FE0-AC8D9121EE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57F0-670E-4A14-8B27-FCD3E8B20F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9232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7F4403-1E78-8B42-781D-425912F873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AB091D8-29C6-5DC2-4F6B-D299816A3E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C7830E-9D31-4D37-0FFE-DE88EA949A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A2791-E7C5-42F3-8DD7-00C8BD603F9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B35EE1-BC40-C051-267F-5C4B8EC28B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D3D956-7E81-859B-4388-E0A3A44A30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57F0-670E-4A14-8B27-FCD3E8B20F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60739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7B1DE3B-0127-F94B-A3E4-DD91BFF582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FACF8F9-9A37-2BE6-A4D1-6AB033274F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A82448-2EC3-D5FD-9D23-0D90F41600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A2791-E7C5-42F3-8DD7-00C8BD603F9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B5B543-440F-D25B-81F3-B3053BABB0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8568CC-BF05-260D-A342-FB73C62A73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57F0-670E-4A14-8B27-FCD3E8B20F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66534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2F0E1D-B5D0-5507-70B8-4276378340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F82DB2-E2AE-5E9F-853A-A549D66F6C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5D4621-F768-2A14-1152-7AE62C101F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A2791-E7C5-42F3-8DD7-00C8BD603F9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B041E9-DEA5-EB18-D1D9-D110F6E261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48093E-60E9-82E5-AD4C-99720E9F5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57F0-670E-4A14-8B27-FCD3E8B20F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4189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619CE3-7486-95E2-3864-706F0FC3A1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922D21-9B35-5102-E852-EB0885AB55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952E0B-88DD-49D1-66F9-FF04D5ED14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A2791-E7C5-42F3-8DD7-00C8BD603F9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FD2166-5BF6-7CD2-6716-7DC772A83A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C37382-EC55-0641-65FD-126FEAB648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57F0-670E-4A14-8B27-FCD3E8B20F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5633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7CE322-01D0-FD8B-CC9D-4A502E4DB3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81145A-EEC5-6D0F-45CB-4717FB54EC6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30FAFA-7ED4-3DE8-826F-4B9B43D072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5DD3B0-4284-354D-BFBA-88B088E2B8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A2791-E7C5-42F3-8DD7-00C8BD603F9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42C21B-EF95-A010-E8CE-11BF83F6D5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3B66FA-1845-22D3-2CF7-5ABFC3149C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57F0-670E-4A14-8B27-FCD3E8B20F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43490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EB5C92-44AE-0CE3-7ACB-340814BC5D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7CAA17-C708-4240-FDFB-F501A52BEF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6BA0E1-4025-7826-8A84-69DAE4ADE1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A2BEEF2-AD42-BDF3-8B1C-CB671858B18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11C3179-4E5E-139B-EF5C-9447712226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EB780FD-3051-8EB2-5D7A-68FD038A6F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A2791-E7C5-42F3-8DD7-00C8BD603F9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02C4B98-DC09-35A7-E4DD-4D9876AF58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F37D74C-547A-6D49-1447-B7C5939B6F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57F0-670E-4A14-8B27-FCD3E8B20F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1718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7F75C8-A285-FB09-59F7-E5D01EFE3A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354C784-DEB6-3596-1129-82A544F8E0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A2791-E7C5-42F3-8DD7-00C8BD603F9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F379F68-C955-44D2-28AC-1D68192D30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70D310E-EFD7-6729-CC21-E23DB3338A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57F0-670E-4A14-8B27-FCD3E8B20F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73134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0520DA-54AF-1334-EE71-6131024966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A2791-E7C5-42F3-8DD7-00C8BD603F9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F8D43BF-895E-BC30-6855-6B8206D860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D486E7F-3C09-F830-4B6A-C2862F8CAD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57F0-670E-4A14-8B27-FCD3E8B20F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453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3C6FE2-B3C2-1411-CD2E-515D1F8899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0BB49E-CE1A-EFB1-659F-EF5CC2A64A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4045AD6-FE2B-4AA5-CEF8-368C957262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047C46-7631-CF58-9C55-92D950BF97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A2791-E7C5-42F3-8DD7-00C8BD603F9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992764-5B6B-573D-7769-BAD2443AC1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74D3B2-1F29-9BF0-3008-96BFDA91A5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57F0-670E-4A14-8B27-FCD3E8B20F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7588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D6E816-5389-21CC-F2FE-DF2C3377CA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7355681-6761-17AA-F8D0-9C956C0C425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163A27-0ED0-F68B-F513-87A7FE9637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99845C-AB50-1EA4-8156-9F6C599583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9A2791-E7C5-42F3-8DD7-00C8BD603F9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162546-83B1-3EBD-8B97-3F64B18ACD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DE531B-26D2-3FDE-7264-C0ACA18F5F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C57F0-670E-4A14-8B27-FCD3E8B20F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9767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4004E81-F65A-BE8C-F708-524F6FF051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2DBECC-5744-984C-0E82-5DC45A3519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162CB2-869E-B6E8-E075-0F8C0A8E65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9A2791-E7C5-42F3-8DD7-00C8BD603F93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758E11-1215-340F-2BC7-F170DF01C6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4FF392-9E49-AFD1-5F52-35FA4310746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60C57F0-670E-4A14-8B27-FCD3E8B20F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76172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9D13042A-BDE5-1C48-D4F6-4721CAF4AEC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8062788"/>
              </p:ext>
            </p:extLst>
          </p:nvPr>
        </p:nvGraphicFramePr>
        <p:xfrm>
          <a:off x="4540102" y="341744"/>
          <a:ext cx="2274584" cy="5924316"/>
        </p:xfrm>
        <a:graphic>
          <a:graphicData uri="http://schemas.openxmlformats.org/drawingml/2006/table">
            <a:tbl>
              <a:tblPr firstRow="1" firstCol="1" bandRow="1"/>
              <a:tblGrid>
                <a:gridCol w="466857">
                  <a:extLst>
                    <a:ext uri="{9D8B030D-6E8A-4147-A177-3AD203B41FA5}">
                      <a16:colId xmlns:a16="http://schemas.microsoft.com/office/drawing/2014/main" val="794905649"/>
                    </a:ext>
                  </a:extLst>
                </a:gridCol>
                <a:gridCol w="382246">
                  <a:extLst>
                    <a:ext uri="{9D8B030D-6E8A-4147-A177-3AD203B41FA5}">
                      <a16:colId xmlns:a16="http://schemas.microsoft.com/office/drawing/2014/main" val="1554824921"/>
                    </a:ext>
                  </a:extLst>
                </a:gridCol>
                <a:gridCol w="341742">
                  <a:extLst>
                    <a:ext uri="{9D8B030D-6E8A-4147-A177-3AD203B41FA5}">
                      <a16:colId xmlns:a16="http://schemas.microsoft.com/office/drawing/2014/main" val="3293268756"/>
                    </a:ext>
                  </a:extLst>
                </a:gridCol>
                <a:gridCol w="379849">
                  <a:extLst>
                    <a:ext uri="{9D8B030D-6E8A-4147-A177-3AD203B41FA5}">
                      <a16:colId xmlns:a16="http://schemas.microsoft.com/office/drawing/2014/main" val="3926461394"/>
                    </a:ext>
                  </a:extLst>
                </a:gridCol>
                <a:gridCol w="358846">
                  <a:extLst>
                    <a:ext uri="{9D8B030D-6E8A-4147-A177-3AD203B41FA5}">
                      <a16:colId xmlns:a16="http://schemas.microsoft.com/office/drawing/2014/main" val="1708238295"/>
                    </a:ext>
                  </a:extLst>
                </a:gridCol>
                <a:gridCol w="345044">
                  <a:extLst>
                    <a:ext uri="{9D8B030D-6E8A-4147-A177-3AD203B41FA5}">
                      <a16:colId xmlns:a16="http://schemas.microsoft.com/office/drawing/2014/main" val="1984778843"/>
                    </a:ext>
                  </a:extLst>
                </a:gridCol>
              </a:tblGrid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BCC8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QP9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N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NTF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ES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11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6776480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BCF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REG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NB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L10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KK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ABP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2594682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CAD10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RF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NB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L11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LL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AF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3125086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COD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RHGEF28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ND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L11A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LL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AM124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74551281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COT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RHGEF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ND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L12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NAJB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AM30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5226511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COT1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RID1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NE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L14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NAJC1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ANC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0784188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COX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RNT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NO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L15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NMT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AP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9139555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CT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SGR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R8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L17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TX3L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ASLG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1941771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CVR1C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TF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15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L1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TX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ASN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70689196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DAM1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XIN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22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L1A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USP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BP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75125458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DAM19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2M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300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L4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USP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BXL7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76976752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DAM8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4GALT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69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L4A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USP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CA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1358239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DAMTS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AD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C20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L4A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2F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CGR3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9479301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DAMTS1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AMBI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C25C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L5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CSC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CGR3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25544849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DAMTS1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ATF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H1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L6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DN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CGR3A/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88207790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DAMTS17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BC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H1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L6A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EF1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CGRT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9885766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DAMTS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BS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H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L6A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GF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CN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9455581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DAMTS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CAT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H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MP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GF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CRL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03986986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DAMTS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CL6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K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PA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GR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GF10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98478761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DAMTS9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IRC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K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RABP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IF2AK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GF1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0180945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DAMTS9-AS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IRC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KN1C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REM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IF2B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GF18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7394636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DCYAP1R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LM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KN2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RIP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IF4EBP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GF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8237184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DGRE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MP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KN2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SF2R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IF4EBP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GF7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6635195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DM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MP8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EACAM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ST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IF5AL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GF9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2170735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DORA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NIP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EBP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ST7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LL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GFBP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7012697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H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NIP3L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EBPD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TGF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LO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GFR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99852469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IF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RC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EBPG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TNNB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LOVL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LN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0068638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KAP1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RCA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ENPF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TTNBP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MP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LRT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4476925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KT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RD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EP5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Xorf3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N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LT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4096404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LDO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RD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ES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YP1B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NC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OS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8831031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LDOC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RIP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ETP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YP3A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NO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OSL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7541044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LOX1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TG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B21D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YP4F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NPEP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PR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7310289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LOX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11orf4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LC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YR6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NPP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PR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2371955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NGPT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15orf5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LDN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YSLTR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PHB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SCN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5683538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NGPT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1QC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LDN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YTIP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PM2AIP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STL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3965756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NGPTL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4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LEC10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AB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PSTI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UC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7421713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NLN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5AR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LEC14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AGL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PX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URIN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1973894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NOS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A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LEC1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AXX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RBB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UT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88825768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NXA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AL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LEC4E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CN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RCC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ZD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9229211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OAH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ASP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LEC9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DB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RCC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ZD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0361562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PC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ASP7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LECL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HOP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RG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ZD8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4534210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PH1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ASP9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LIC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DR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RO1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ZD9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4779758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PI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AV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LIC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DX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SR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ADD45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1797730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PLN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BLC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NKSR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DX50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VI2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AS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6560652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POL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BR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NN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EFB13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XO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AT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7744364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QP9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L3/L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NOT10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EPTO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ZH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ATA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70536600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ATA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GF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TGAV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TA4H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SC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OASL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111399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BP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IF1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TGB7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TB4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SH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OAZ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6560103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BP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IP1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TGB8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TB4R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SH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OLFML2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0618613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BP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IST1H1C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TPK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TBP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TMR1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OLR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4720252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CH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IST2H2AA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JAG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Y6E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TO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OTO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3626542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EM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IVEP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JAG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YZ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PT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2RX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26611906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H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K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JUN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FF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X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2RY1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0180936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IMAP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K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ALRN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GEA3/A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XI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4H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68788060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IMAP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LA-DO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AT2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LT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YC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4HA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9815493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LG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LA-DQA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CNAB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ML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YCT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ADI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9044512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LI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LA-DRB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CNJ1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N2B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YH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ALMD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97307270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LS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LA-DRB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DM6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P2K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YOD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AMR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2962272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LUD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LA-F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D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P3K1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BN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ARP1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7304596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LUL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MG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IF20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P3K1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CF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ARP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3429494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MIP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NF1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IF2C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P3K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COR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ARP9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8118239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NAI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NF1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ITLG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P3K8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DC80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BX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9920360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NG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OXD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LF10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PK10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DUFA4L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BX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5493486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OT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PGD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LK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PK1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DUFA7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C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4400869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OT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PGDS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LRC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PK1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ECTIN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CK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1625504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PATCH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PRT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LRC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RCKSL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ECTIN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CLAF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006746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PC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S3ST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RAS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EGF9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VRL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DE4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1432878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PNM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SD17B1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RB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ELK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EIL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DGF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4090110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PR14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SPG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YNU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ET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F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DGF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0223015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PR1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CAM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AIR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FNG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FAM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DGFR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5712040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PR160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D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AM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GMT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FIL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DK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1406136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PR18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D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AMB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KI67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FKBIE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DZK1IP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4827768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PR6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D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AMB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LAN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FKBIZ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ELI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798364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PSM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D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AMC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LH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FYC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F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4402681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RN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DO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APTM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MP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GF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FDN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7574489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SN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ER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AT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MP1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GF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FKFB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8293931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TF2H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FI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AT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MP1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ID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FKM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5967027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US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FI4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DH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MP19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KG7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GGT1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7320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2AFX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FI44L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DH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MP7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LRP1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GLYRP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65787662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AVCR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FIT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DL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MP8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M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GPEP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1668290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BEGF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FNGR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GALS9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MP9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OTCH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HEX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15675490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DAC1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GF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GMN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MRN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OX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HLDA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91084371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DAC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GF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ILRA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ND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OX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IAS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0324419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DAC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HH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ILRB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OK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OX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IK3C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5455922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DAC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KZF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IP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PEG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R1H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IK3R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0233313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DAC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L27R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OX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PO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R2F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IK3R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0427265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DC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L3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OXL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RC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R4A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IK3R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8035190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ELLS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L4I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PL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RE1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RAS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IM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0609042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ERC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NHB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RP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RPL19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RDE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KM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2587912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ERC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NSIG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RP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RPS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RIP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LA1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966362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ES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NS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RRC3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S4A4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OAS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LA2G2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85650051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EY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RF9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ST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S4A6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OAS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LA2G7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7585514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LD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AD50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ELP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PHK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OP2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NT1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1327961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LOD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AD5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EMA4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PI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PI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NT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6966845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LSCR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AD51C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EMA4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PRY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PM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NT2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4740930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LVAP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AF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EMA5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PRY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PSAB1/B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NT3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9898663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MS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APGEF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EMA6D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PTBN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RAF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NT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9029730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NOC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ASAL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ERPIN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QSTM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RAFD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NT5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4240601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OLD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ASGRF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ERPINB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REBF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RANK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NT5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41036400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OLR2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ASGRF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ERPINB9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RP5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RAT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NT7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3371719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PARGC1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B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ERPINE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TAB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REX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XBP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3546082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G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BL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ERPINE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TAT5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RIM2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XCL1/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5319914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KAA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ELN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ERPINH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TC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SLP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YAP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6894809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KAC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EN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F3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TEAP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SPAN8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YES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1644254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KC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ETNL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F3A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TK11IP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TC30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ZC3H12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0412977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KCI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GS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FRP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TK17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UBA1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ZC3H1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01462064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KX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GS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FRP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AF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UBA4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ZEB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8087032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L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HOC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FXN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AGLN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WF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ZEB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9670159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K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HOG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GK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APBPL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WIST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ZFP9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4118923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M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HOJ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GPP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BC1D10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WIST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ZNF148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1159130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S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ICTO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HC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BP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WISTN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ZNRF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637275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PF38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IPK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IGLEC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BXAS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XN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3512390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R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IPK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IGLEC8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CF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XNDC1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9680424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RX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NASE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IRP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CL1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YMP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1136981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SMB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NASE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IRPB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DO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YMS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8364237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SMC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ND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KI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EP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YROBP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9863846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SME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NLS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KIL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FCP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UBA7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9241372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TAF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OBO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LC16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GF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UB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188143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TCD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OCK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LC16A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GFB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UBE2C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31970133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TCR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OR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LC16A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GFBR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UBE2T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8576785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TEN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OS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LC1A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GFBR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USP18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1716055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TGD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PL2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LC2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GFBR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VAMP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7869512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TGDS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PL7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LC7A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GM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VASP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001138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TGER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PS6KB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LCO2A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IE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VAV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3910051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TGER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PTO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MAD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IMD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VAV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78624243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TGS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RM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MAD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IMP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VCAN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6697350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TPN1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SAD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MAD7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M4SF19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VEGF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2436535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TPN1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TP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MAP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M7SF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VNN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7664481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TPR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UNX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MARCD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MEM140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VHL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8530826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45RB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100A10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NAI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MEM17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VRK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2994051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45R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100A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NC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MUB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VSIR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7140882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45RO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100A9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OCS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NC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VTCN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6053528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TPRK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1PR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OCS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NFAIP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VWA5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5622976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TX3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AMD9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OX10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NFAIP8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VWF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7676642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UM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AMSN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OX11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NFRSF10D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AS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6083626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VRIG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AP130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OX2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NFRSF25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DR76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9074660"/>
                  </a:ext>
                </a:extLst>
              </a:tr>
              <a:tr h="7433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AB20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CIN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P4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NFSF9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FDC21P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3413827"/>
                  </a:ext>
                </a:extLst>
              </a:tr>
              <a:tr h="363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AB3D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DH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PATS2L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NKS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NT10A</a:t>
                      </a:r>
                      <a:endParaRPr lang="en-GB" sz="200" kern="10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2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200" kern="100" dirty="0">
                        <a:effectLst/>
                        <a:latin typeface="Calibri" panose="020F050202020403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11147" marR="1114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5252129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D8CA715A-0257-0C63-F595-E2BC85DAAD28}"/>
              </a:ext>
            </a:extLst>
          </p:cNvPr>
          <p:cNvSpPr txBox="1"/>
          <p:nvPr/>
        </p:nvSpPr>
        <p:spPr>
          <a:xfrm>
            <a:off x="683394" y="1443789"/>
            <a:ext cx="284907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Supplementary Figure 2. </a:t>
            </a:r>
            <a:r>
              <a:rPr lang="en-GB" sz="1600" dirty="0" err="1"/>
              <a:t>Nanostring</a:t>
            </a:r>
            <a:r>
              <a:rPr lang="en-GB" sz="1600" dirty="0"/>
              <a:t> gene panel</a:t>
            </a:r>
          </a:p>
        </p:txBody>
      </p:sp>
    </p:spTree>
    <p:extLst>
      <p:ext uri="{BB962C8B-B14F-4D97-AF65-F5344CB8AC3E}">
        <p14:creationId xmlns:p14="http://schemas.microsoft.com/office/powerpoint/2010/main" val="2459034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843</Words>
  <Application>Microsoft Office PowerPoint</Application>
  <PresentationFormat>Widescreen</PresentationFormat>
  <Paragraphs>8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emertzidou, Anysia</dc:creator>
  <cp:lastModifiedBy>Semertzidou, Anysia</cp:lastModifiedBy>
  <cp:revision>1</cp:revision>
  <dcterms:created xsi:type="dcterms:W3CDTF">2025-10-06T12:58:45Z</dcterms:created>
  <dcterms:modified xsi:type="dcterms:W3CDTF">2025-10-30T16:19:04Z</dcterms:modified>
</cp:coreProperties>
</file>